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4"/>
    <p:restoredTop sz="97164"/>
  </p:normalViewPr>
  <p:slideViewPr>
    <p:cSldViewPr snapToGrid="0" snapToObjects="1">
      <p:cViewPr varScale="1">
        <p:scale>
          <a:sx n="64" d="100"/>
          <a:sy n="64" d="100"/>
        </p:scale>
        <p:origin x="26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219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623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247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17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805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35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690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401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07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30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843E-8716-284F-82F6-416ECE7F5D5E}" type="datetimeFigureOut">
              <a:rPr lang="en-US" smtClean="0"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6D630-AB5D-E14B-8567-92581624BFD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049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1F9A2E3-0DAE-C54E-8B5C-E540611F6291}"/>
              </a:ext>
            </a:extLst>
          </p:cNvPr>
          <p:cNvGrpSpPr/>
          <p:nvPr/>
        </p:nvGrpSpPr>
        <p:grpSpPr>
          <a:xfrm>
            <a:off x="473290" y="1545020"/>
            <a:ext cx="5769203" cy="2758412"/>
            <a:chOff x="964800" y="1371600"/>
            <a:chExt cx="6066497" cy="2682686"/>
          </a:xfrm>
        </p:grpSpPr>
        <p:pic>
          <p:nvPicPr>
            <p:cNvPr id="4" name="Picture 6" descr="page1image44135840">
              <a:extLst>
                <a:ext uri="{FF2B5EF4-FFF2-40B4-BE49-F238E27FC236}">
                  <a16:creationId xmlns:a16="http://schemas.microsoft.com/office/drawing/2014/main" id="{6244AB45-490C-9E49-8C1F-16F14FF7398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15" b="11670"/>
            <a:stretch/>
          </p:blipFill>
          <p:spPr bwMode="auto">
            <a:xfrm>
              <a:off x="964800" y="1371600"/>
              <a:ext cx="5994400" cy="23473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90588F7-5A6B-124E-91E7-CB71D0A1F702}"/>
                </a:ext>
              </a:extLst>
            </p:cNvPr>
            <p:cNvSpPr txBox="1"/>
            <p:nvPr/>
          </p:nvSpPr>
          <p:spPr>
            <a:xfrm>
              <a:off x="1055481" y="3665160"/>
              <a:ext cx="5975816" cy="38912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1  	                         10   	                     100 	                 1000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ours (logarithmic axes)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3117D346-B971-BA48-8B9D-69DF580790B7}"/>
                </a:ext>
              </a:extLst>
            </p:cNvPr>
            <p:cNvCxnSpPr/>
            <p:nvPr/>
          </p:nvCxnSpPr>
          <p:spPr>
            <a:xfrm>
              <a:off x="3326400" y="1450976"/>
              <a:ext cx="0" cy="216000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C050C60-1DA8-5E4E-AB7E-61C091EA2E53}"/>
              </a:ext>
            </a:extLst>
          </p:cNvPr>
          <p:cNvSpPr txBox="1"/>
          <p:nvPr/>
        </p:nvSpPr>
        <p:spPr>
          <a:xfrm>
            <a:off x="559527" y="4359145"/>
            <a:ext cx="561440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stribution of the timing of Midodrine prescription after ICU admission (hours) of the entire Midodrine group, before the application of the inclusion criteria selecting patients with ≥ 12h hours of vasopressor (dotted line)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5B09A8-9A7C-0747-A130-CFF177612165}"/>
              </a:ext>
            </a:extLst>
          </p:cNvPr>
          <p:cNvSpPr txBox="1"/>
          <p:nvPr/>
        </p:nvSpPr>
        <p:spPr>
          <a:xfrm>
            <a:off x="609600" y="1148422"/>
            <a:ext cx="901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-1</a:t>
            </a:r>
          </a:p>
        </p:txBody>
      </p:sp>
    </p:spTree>
    <p:extLst>
      <p:ext uri="{BB962C8B-B14F-4D97-AF65-F5344CB8AC3E}">
        <p14:creationId xmlns:p14="http://schemas.microsoft.com/office/powerpoint/2010/main" val="3310114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4</TotalTime>
  <Words>56</Words>
  <Application>Microsoft Office PowerPoint</Application>
  <PresentationFormat>Format US (216 x 279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charbonney echarbonney</dc:creator>
  <cp:lastModifiedBy>Jan-Alexis Tremblay</cp:lastModifiedBy>
  <cp:revision>10</cp:revision>
  <dcterms:created xsi:type="dcterms:W3CDTF">2020-07-31T00:16:02Z</dcterms:created>
  <dcterms:modified xsi:type="dcterms:W3CDTF">2020-07-31T20:18:58Z</dcterms:modified>
</cp:coreProperties>
</file>